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8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B620C-9354-A818-9F85-F55B513D6D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25F3AEB-FD96-CE1D-9F4A-F8BFB75B8B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C4633B-8A25-93B7-CCCB-ED9650DB38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EF4595-1983-91C5-6297-B4150CF5C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C5C98B-16AA-9531-F1A8-423BBA593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711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72293-30BC-81B6-1B57-26D373104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0A28E8-B799-2C26-1A09-80A822F4BC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B3B4C-3B12-CB28-92F2-5BEA5DC3B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195B6-5C65-ED24-2123-3ED981451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F09CC4-3A84-D92A-C62D-BA9F05E3C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72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67BC8A-94AD-7ABC-B363-3D156047FD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8641BC-975B-230B-38B1-E90FB425B1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94DC42-D6CB-C38C-7CB2-DC037C128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89E20C-95F7-2440-2C15-30324232C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3B30BE-F920-6C92-6D45-C7163D6AD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773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A285EA-4C37-DE0D-8373-73B69DF17B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C9486F-AFEE-B40A-B1B2-C15D963350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6F0415-8002-CE1A-C811-DABF8138E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957100-1DBD-59A8-5F6A-945A102A7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DA0E76-6820-2923-6F12-82E51C278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529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99E07E-9C08-B59C-3F95-5AAE802577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2DE3DB-7C61-F4FB-F20B-B313D2D160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4E75A0-0872-49AF-EC4C-B32EAF211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7D9CBE-1DF2-9539-198B-5B4C4B8CD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9BC24E-9860-F4C6-223B-57A0EA4F3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722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87DAF2-1BDE-852B-083F-0C3567DB9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D6A7AA-2000-AC67-7029-488A90113C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D028A9-94B2-C1CE-DC07-7AAEA7F4FB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2DBCEB-217E-FF97-7144-885932E945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6AA710-B9FA-C166-C259-B63C7D91C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7568B0-8BC4-6C92-0CBA-DC36FB684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935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3B4E8B-92BD-9DFE-74D3-166C1B541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3F7CC0-7652-C218-5C38-81C26C3945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23ED8D-6DC9-684B-A0BF-468CCE3182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8BA525F-BA54-F665-B5CD-543C4856DF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EF482F-C25C-ED97-67CF-F19EB94A89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BCD7CA-99DF-2DC8-26AC-9FD49444E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DE7C61-257E-BED7-D517-D8211F68E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543C2F-7AFD-BC26-4239-AB8CB03A16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438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92ED9-00D9-04CB-40B3-ABA8C9E6B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089B57-EF12-396E-8370-AF66EE1B1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EAAD41-1E40-7E5F-DA9C-AA237DC96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FB72B56-73E9-B19C-B0EC-EAE10DCF5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677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542695-73FB-4598-ED14-9F89C720C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B63B6C-6035-C96D-D396-E505F053E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1948F6-03FE-2946-B7AB-A9509C77F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560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93997B-3D0E-8ECC-9726-722A0F4FD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E65523-9776-71E1-A200-0FBB096AE7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2839A7-FBA9-9208-01F2-63AE4DDB5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047B02-DFEC-01BE-F20A-8B256AB56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2DB705-D83B-EFDB-2F35-9412ED2F9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4C713C-3380-ED8B-F6A2-5F1BF6AEF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87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6B864C-975F-4C6E-20DA-066CA990D2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908496-D981-4011-6102-012DA2C493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6A9D96-2CB3-CA3D-7067-8CD46F12A7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51A275-0AB0-A3D9-BB10-700A42095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B42F3B-E51C-999B-E684-048B71467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6DA3C4-90CC-1499-0DAD-39CBF3116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10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58D7CA-D042-EB71-F2BC-9C30809139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429958-99C9-7294-F86D-8AAB11773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2ABFAF-FFA8-A402-730A-FAA264802A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41AC43-DA59-4E5E-86F0-E469B3F3527B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B6E0D3-81CA-5EF2-CCA8-1670E4C3DD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731B75-35E6-1D55-A611-D6F70FEA2B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8BE83-569F-43AC-9DF6-319C95054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599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5A7F62B-D999-A00D-5D66-22E4D9D8CE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5669791"/>
              </p:ext>
            </p:extLst>
          </p:nvPr>
        </p:nvGraphicFramePr>
        <p:xfrm>
          <a:off x="1704975" y="1341438"/>
          <a:ext cx="3848100" cy="2717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848050" imgH="2718443" progId="Prism9.Document">
                  <p:embed/>
                </p:oleObj>
              </mc:Choice>
              <mc:Fallback>
                <p:oleObj name="Prism 9" r:id="rId2" imgW="3848050" imgH="2718443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41A4B3B5-B51B-ECD4-98F7-B8DA374100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04975" y="1341438"/>
                        <a:ext cx="3848100" cy="2717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70E0B51-D4D5-B5B5-0629-4422D7D34D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9594440"/>
              </p:ext>
            </p:extLst>
          </p:nvPr>
        </p:nvGraphicFramePr>
        <p:xfrm>
          <a:off x="5528970" y="1308894"/>
          <a:ext cx="3852863" cy="2782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852732" imgH="2782550" progId="Prism9.Document">
                  <p:embed/>
                </p:oleObj>
              </mc:Choice>
              <mc:Fallback>
                <p:oleObj name="Prism 9" r:id="rId4" imgW="3852732" imgH="2782550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43737FC-358C-A548-B8CD-8E70B8F7F2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28970" y="1308894"/>
                        <a:ext cx="3852863" cy="2782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3F8F789-518C-E95F-7F33-F6FF0B6B7F01}"/>
              </a:ext>
            </a:extLst>
          </p:cNvPr>
          <p:cNvSpPr txBox="1"/>
          <p:nvPr/>
        </p:nvSpPr>
        <p:spPr>
          <a:xfrm>
            <a:off x="2453429" y="2967335"/>
            <a:ext cx="6094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p&lt;0.0001</a:t>
            </a:r>
          </a:p>
          <a:p>
            <a:r>
              <a:rPr lang="en-US" sz="800" b="1" dirty="0"/>
              <a:t>HR: 4.1</a:t>
            </a:r>
          </a:p>
          <a:p>
            <a:r>
              <a:rPr lang="en-US" sz="800" b="1" dirty="0"/>
              <a:t>CI: 3.0-5.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619F3F-EFA0-8CEB-D95A-CA248CF0BCEF}"/>
              </a:ext>
            </a:extLst>
          </p:cNvPr>
          <p:cNvSpPr txBox="1"/>
          <p:nvPr/>
        </p:nvSpPr>
        <p:spPr>
          <a:xfrm>
            <a:off x="6334196" y="2964967"/>
            <a:ext cx="6094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p&lt;0.0001</a:t>
            </a:r>
          </a:p>
          <a:p>
            <a:r>
              <a:rPr lang="en-US" sz="800" b="1" dirty="0"/>
              <a:t>HR: 2.2</a:t>
            </a:r>
          </a:p>
          <a:p>
            <a:r>
              <a:rPr lang="en-US" sz="800" b="1" dirty="0"/>
              <a:t>CI: 1.6-3.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E32646-DE21-5201-13D9-9754A50C08D6}"/>
              </a:ext>
            </a:extLst>
          </p:cNvPr>
          <p:cNvSpPr txBox="1"/>
          <p:nvPr/>
        </p:nvSpPr>
        <p:spPr>
          <a:xfrm>
            <a:off x="2046914" y="124178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7646286-06BC-0E75-BB10-F0ED611E15A1}"/>
              </a:ext>
            </a:extLst>
          </p:cNvPr>
          <p:cNvSpPr txBox="1"/>
          <p:nvPr/>
        </p:nvSpPr>
        <p:spPr>
          <a:xfrm>
            <a:off x="5880527" y="124200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6A1F2B-6BBC-1C6E-F622-9BD5CD5B2CB8}"/>
              </a:ext>
            </a:extLst>
          </p:cNvPr>
          <p:cNvSpPr txBox="1"/>
          <p:nvPr/>
        </p:nvSpPr>
        <p:spPr>
          <a:xfrm>
            <a:off x="1749949" y="4086731"/>
            <a:ext cx="7631884" cy="6752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Figure 6. Prognostic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mpact of Stage in OSCC. 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Shown are Kaplan-Meier estimates of Overall Survival (A) and Progression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F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re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urvival (B) according to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early and advanced stag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OSCC patients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HR: Hazard Ratio, CI: 95% confidence interval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53433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69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>The University of Iow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gpattaraworakul, Wattawan</dc:creator>
  <cp:lastModifiedBy>Burnett, Andrean L</cp:lastModifiedBy>
  <cp:revision>4</cp:revision>
  <dcterms:created xsi:type="dcterms:W3CDTF">2023-06-19T21:18:18Z</dcterms:created>
  <dcterms:modified xsi:type="dcterms:W3CDTF">2024-05-01T17:41:28Z</dcterms:modified>
</cp:coreProperties>
</file>